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B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5" autoAdjust="0"/>
    <p:restoredTop sz="94660"/>
  </p:normalViewPr>
  <p:slideViewPr>
    <p:cSldViewPr snapToGrid="0">
      <p:cViewPr varScale="1">
        <p:scale>
          <a:sx n="50" d="100"/>
          <a:sy n="50" d="100"/>
        </p:scale>
        <p:origin x="36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0218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5216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1420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8221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3008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3357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7366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5119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181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5026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665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39B3D-E2BE-41A4-8F70-3CAE49902FEF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6E88C5-676C-4CA0-9D43-21A7BE39FD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3668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Flèche : droite 82">
            <a:extLst>
              <a:ext uri="{FF2B5EF4-FFF2-40B4-BE49-F238E27FC236}">
                <a16:creationId xmlns:a16="http://schemas.microsoft.com/office/drawing/2014/main" id="{13B4FB0B-6F25-42B6-8CB9-7F6C28F4CC09}"/>
              </a:ext>
            </a:extLst>
          </p:cNvPr>
          <p:cNvSpPr/>
          <p:nvPr/>
        </p:nvSpPr>
        <p:spPr>
          <a:xfrm>
            <a:off x="3713537" y="1736719"/>
            <a:ext cx="629728" cy="336430"/>
          </a:xfrm>
          <a:prstGeom prst="rightArrow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7" name="ZoneTexte 86">
            <a:extLst>
              <a:ext uri="{FF2B5EF4-FFF2-40B4-BE49-F238E27FC236}">
                <a16:creationId xmlns:a16="http://schemas.microsoft.com/office/drawing/2014/main" id="{9E987A15-A077-4B9C-B74F-D108AAE7B238}"/>
              </a:ext>
            </a:extLst>
          </p:cNvPr>
          <p:cNvSpPr txBox="1"/>
          <p:nvPr/>
        </p:nvSpPr>
        <p:spPr>
          <a:xfrm>
            <a:off x="8713596" y="0"/>
            <a:ext cx="11849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33">
            <a:extLst>
              <a:ext uri="{FF2B5EF4-FFF2-40B4-BE49-F238E27FC236}">
                <a16:creationId xmlns:a16="http://schemas.microsoft.com/office/drawing/2014/main" id="{43DF47CA-4592-4FE4-8FE4-370E92C4DF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7078" y="241274"/>
            <a:ext cx="1859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endParaRPr kumimoji="0" lang="fr-FR" altLang="fr-FR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9" name="Rectangle 33">
            <a:extLst>
              <a:ext uri="{FF2B5EF4-FFF2-40B4-BE49-F238E27FC236}">
                <a16:creationId xmlns:a16="http://schemas.microsoft.com/office/drawing/2014/main" id="{A3C08994-C614-4D78-8029-32B3A6CDE0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07308" y="3828115"/>
            <a:ext cx="18594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2000" b="1" dirty="0">
                <a:solidFill>
                  <a:srgbClr val="000000"/>
                </a:solidFill>
              </a:rPr>
              <a:t>B</a:t>
            </a:r>
            <a:endParaRPr kumimoji="0" lang="fr-FR" altLang="fr-FR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E1B4354B-6CE4-4983-BE8B-68A524E67352}"/>
              </a:ext>
            </a:extLst>
          </p:cNvPr>
          <p:cNvGrpSpPr/>
          <p:nvPr/>
        </p:nvGrpSpPr>
        <p:grpSpPr>
          <a:xfrm>
            <a:off x="1073287" y="757922"/>
            <a:ext cx="2599325" cy="2676786"/>
            <a:chOff x="981847" y="715100"/>
            <a:chExt cx="2599325" cy="2676786"/>
          </a:xfrm>
        </p:grpSpPr>
        <p:pic>
          <p:nvPicPr>
            <p:cNvPr id="82" name="Image 81">
              <a:extLst>
                <a:ext uri="{FF2B5EF4-FFF2-40B4-BE49-F238E27FC236}">
                  <a16:creationId xmlns:a16="http://schemas.microsoft.com/office/drawing/2014/main" id="{11A9E020-F4D1-4429-91CD-84662593772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96035" y="715100"/>
              <a:ext cx="2585137" cy="2676786"/>
            </a:xfrm>
            <a:prstGeom prst="rect">
              <a:avLst/>
            </a:prstGeom>
          </p:spPr>
        </p:pic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191876CB-1FD9-4DC5-877F-FEFA5770525A}"/>
                </a:ext>
              </a:extLst>
            </p:cNvPr>
            <p:cNvSpPr txBox="1"/>
            <p:nvPr/>
          </p:nvSpPr>
          <p:spPr>
            <a:xfrm>
              <a:off x="1695589" y="937358"/>
              <a:ext cx="379912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fr-FR" sz="1000" b="1" dirty="0">
                  <a:solidFill>
                    <a:srgbClr val="00CB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50</a:t>
              </a:r>
            </a:p>
          </p:txBody>
        </p:sp>
        <p:sp>
          <p:nvSpPr>
            <p:cNvPr id="90" name="ZoneTexte 89">
              <a:extLst>
                <a:ext uri="{FF2B5EF4-FFF2-40B4-BE49-F238E27FC236}">
                  <a16:creationId xmlns:a16="http://schemas.microsoft.com/office/drawing/2014/main" id="{3457E0AF-F64B-4022-8E82-812F91C41D8A}"/>
                </a:ext>
              </a:extLst>
            </p:cNvPr>
            <p:cNvSpPr txBox="1"/>
            <p:nvPr/>
          </p:nvSpPr>
          <p:spPr>
            <a:xfrm>
              <a:off x="2897553" y="937358"/>
              <a:ext cx="379912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fr-F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229</a:t>
              </a:r>
            </a:p>
          </p:txBody>
        </p: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5ECE5C95-663F-47BC-B49E-9FAB9270877E}"/>
                </a:ext>
              </a:extLst>
            </p:cNvPr>
            <p:cNvSpPr txBox="1"/>
            <p:nvPr/>
          </p:nvSpPr>
          <p:spPr>
            <a:xfrm>
              <a:off x="1800273" y="3192878"/>
              <a:ext cx="1362552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fr-F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change (log2-ratio)</a:t>
              </a:r>
            </a:p>
          </p:txBody>
        </p:sp>
        <p:sp>
          <p:nvSpPr>
            <p:cNvPr id="92" name="ZoneTexte 91">
              <a:extLst>
                <a:ext uri="{FF2B5EF4-FFF2-40B4-BE49-F238E27FC236}">
                  <a16:creationId xmlns:a16="http://schemas.microsoft.com/office/drawing/2014/main" id="{FCBB75E9-585D-499F-89E6-7D6DF9038AA4}"/>
                </a:ext>
              </a:extLst>
            </p:cNvPr>
            <p:cNvSpPr txBox="1"/>
            <p:nvPr/>
          </p:nvSpPr>
          <p:spPr>
            <a:xfrm rot="16200000">
              <a:off x="611553" y="1767938"/>
              <a:ext cx="894476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p-value (-log10)</a:t>
              </a:r>
            </a:p>
          </p:txBody>
        </p:sp>
      </p:grpSp>
      <p:sp>
        <p:nvSpPr>
          <p:cNvPr id="93" name="Rectangle 33">
            <a:extLst>
              <a:ext uri="{FF2B5EF4-FFF2-40B4-BE49-F238E27FC236}">
                <a16:creationId xmlns:a16="http://schemas.microsoft.com/office/drawing/2014/main" id="{2C1B1D70-3A6C-4EEC-988B-855381F56D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4995" y="399114"/>
            <a:ext cx="12198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earning set</a:t>
            </a:r>
            <a:endParaRPr kumimoji="0" lang="fr-FR" altLang="fr-FR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4" name="Rectangle 33">
            <a:extLst>
              <a:ext uri="{FF2B5EF4-FFF2-40B4-BE49-F238E27FC236}">
                <a16:creationId xmlns:a16="http://schemas.microsoft.com/office/drawing/2014/main" id="{06A47580-D83D-4927-A483-F17EE03CF2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44894" y="3878914"/>
            <a:ext cx="132395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alidation set</a:t>
            </a:r>
            <a:endParaRPr kumimoji="0" lang="fr-FR" altLang="fr-FR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5" name="ZoneTexte 54">
            <a:extLst>
              <a:ext uri="{FF2B5EF4-FFF2-40B4-BE49-F238E27FC236}">
                <a16:creationId xmlns:a16="http://schemas.microsoft.com/office/drawing/2014/main" id="{6F3BDEC1-B333-49ED-8523-1D3F1F98CA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13169" y="2390777"/>
            <a:ext cx="124906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1000" dirty="0" err="1">
                <a:latin typeface="Arial" panose="020B0604020202020204" pitchFamily="34" charset="0"/>
              </a:rPr>
              <a:t>Fisher’s</a:t>
            </a:r>
            <a:r>
              <a:rPr lang="fr-FR" altLang="fr-FR" sz="1000" dirty="0">
                <a:latin typeface="Arial" panose="020B0604020202020204" pitchFamily="34" charset="0"/>
              </a:rPr>
              <a:t> exact test,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1000" dirty="0">
                <a:latin typeface="Arial" panose="020B0604020202020204" pitchFamily="34" charset="0"/>
              </a:rPr>
              <a:t>p=9.29E-21</a:t>
            </a:r>
          </a:p>
        </p:txBody>
      </p:sp>
      <p:grpSp>
        <p:nvGrpSpPr>
          <p:cNvPr id="96" name="Group 28">
            <a:extLst>
              <a:ext uri="{FF2B5EF4-FFF2-40B4-BE49-F238E27FC236}">
                <a16:creationId xmlns:a16="http://schemas.microsoft.com/office/drawing/2014/main" id="{A96A10D9-7960-4660-A3F4-0553B85F6EA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7089056" y="1171786"/>
            <a:ext cx="1726932" cy="1087218"/>
            <a:chOff x="913" y="2506"/>
            <a:chExt cx="1566" cy="542"/>
          </a:xfrm>
        </p:grpSpPr>
        <p:sp>
          <p:nvSpPr>
            <p:cNvPr id="98" name="Rectangle 29">
              <a:extLst>
                <a:ext uri="{FF2B5EF4-FFF2-40B4-BE49-F238E27FC236}">
                  <a16:creationId xmlns:a16="http://schemas.microsoft.com/office/drawing/2014/main" id="{565B1EC4-38C6-41F7-A066-D7344748AB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5" y="2506"/>
              <a:ext cx="1058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b="1" dirty="0">
                  <a:solidFill>
                    <a:srgbClr val="000000"/>
                  </a:solidFill>
                </a:rPr>
                <a:t>CSPG4 classification</a:t>
              </a:r>
              <a:endParaRPr lang="fr-FR" altLang="fr-FR" sz="1800" b="1" dirty="0">
                <a:latin typeface="Arial" panose="020B0604020202020204" pitchFamily="34" charset="0"/>
              </a:endParaRPr>
            </a:p>
          </p:txBody>
        </p:sp>
        <p:sp>
          <p:nvSpPr>
            <p:cNvPr id="99" name="Rectangle 30">
              <a:extLst>
                <a:ext uri="{FF2B5EF4-FFF2-40B4-BE49-F238E27FC236}">
                  <a16:creationId xmlns:a16="http://schemas.microsoft.com/office/drawing/2014/main" id="{CDD1E96D-E4B7-437D-9DD3-FAC0EB57CA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5" y="2686"/>
              <a:ext cx="4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>
                  <a:solidFill>
                    <a:srgbClr val="000000"/>
                  </a:solidFill>
                </a:rPr>
                <a:t>Observed</a:t>
              </a:r>
              <a:endParaRPr lang="fr-FR" altLang="fr-FR" sz="1800">
                <a:latin typeface="Arial" panose="020B0604020202020204" pitchFamily="34" charset="0"/>
              </a:endParaRPr>
            </a:p>
          </p:txBody>
        </p:sp>
        <p:sp>
          <p:nvSpPr>
            <p:cNvPr id="100" name="Rectangle 31">
              <a:extLst>
                <a:ext uri="{FF2B5EF4-FFF2-40B4-BE49-F238E27FC236}">
                  <a16:creationId xmlns:a16="http://schemas.microsoft.com/office/drawing/2014/main" id="{B4AAC7A2-B570-426A-B858-0796704493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" y="2698"/>
              <a:ext cx="18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>
                  <a:solidFill>
                    <a:srgbClr val="000000"/>
                  </a:solidFill>
                </a:rPr>
                <a:t>low</a:t>
              </a:r>
              <a:endParaRPr lang="fr-FR" altLang="fr-FR" sz="1800">
                <a:latin typeface="Arial" panose="020B0604020202020204" pitchFamily="34" charset="0"/>
              </a:endParaRPr>
            </a:p>
          </p:txBody>
        </p:sp>
        <p:sp>
          <p:nvSpPr>
            <p:cNvPr id="101" name="Rectangle 32">
              <a:extLst>
                <a:ext uri="{FF2B5EF4-FFF2-40B4-BE49-F238E27FC236}">
                  <a16:creationId xmlns:a16="http://schemas.microsoft.com/office/drawing/2014/main" id="{6AA25CC1-D6F8-4A13-A833-420DD2E327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8" y="2698"/>
              <a:ext cx="222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>
                  <a:solidFill>
                    <a:srgbClr val="000000"/>
                  </a:solidFill>
                </a:rPr>
                <a:t>high</a:t>
              </a:r>
              <a:endParaRPr lang="fr-FR" altLang="fr-FR" sz="1800">
                <a:latin typeface="Arial" panose="020B0604020202020204" pitchFamily="34" charset="0"/>
              </a:endParaRPr>
            </a:p>
          </p:txBody>
        </p:sp>
        <p:sp>
          <p:nvSpPr>
            <p:cNvPr id="102" name="Rectangle 33">
              <a:extLst>
                <a:ext uri="{FF2B5EF4-FFF2-40B4-BE49-F238E27FC236}">
                  <a16:creationId xmlns:a16="http://schemas.microsoft.com/office/drawing/2014/main" id="{6A8D07F8-A019-46D1-875D-724C6E3F84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4" y="2817"/>
              <a:ext cx="18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 err="1">
                  <a:solidFill>
                    <a:srgbClr val="000000"/>
                  </a:solidFill>
                </a:rPr>
                <a:t>low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03" name="Rectangle 34">
              <a:extLst>
                <a:ext uri="{FF2B5EF4-FFF2-40B4-BE49-F238E27FC236}">
                  <a16:creationId xmlns:a16="http://schemas.microsoft.com/office/drawing/2014/main" id="{504FEA87-1838-4E48-8EC1-9ACD2F8678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1" y="2817"/>
              <a:ext cx="196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138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04" name="Rectangle 35">
              <a:extLst>
                <a:ext uri="{FF2B5EF4-FFF2-40B4-BE49-F238E27FC236}">
                  <a16:creationId xmlns:a16="http://schemas.microsoft.com/office/drawing/2014/main" id="{6E03C57D-E449-465D-AF02-D9AA7CB6DD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4" y="2817"/>
              <a:ext cx="131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41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05" name="Rectangle 36">
              <a:extLst>
                <a:ext uri="{FF2B5EF4-FFF2-40B4-BE49-F238E27FC236}">
                  <a16:creationId xmlns:a16="http://schemas.microsoft.com/office/drawing/2014/main" id="{22E1DEC4-5BCC-4950-A338-1369B01BD9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4" y="2935"/>
              <a:ext cx="222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high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06" name="Rectangle 37">
              <a:extLst>
                <a:ext uri="{FF2B5EF4-FFF2-40B4-BE49-F238E27FC236}">
                  <a16:creationId xmlns:a16="http://schemas.microsoft.com/office/drawing/2014/main" id="{58EE6FE6-6158-4C82-905D-FCB8236049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6" y="2935"/>
              <a:ext cx="131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32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07" name="Rectangle 38">
              <a:extLst>
                <a:ext uri="{FF2B5EF4-FFF2-40B4-BE49-F238E27FC236}">
                  <a16:creationId xmlns:a16="http://schemas.microsoft.com/office/drawing/2014/main" id="{2CBA6FF8-DEB8-4353-8DB6-BD1ADC9F15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4" y="2935"/>
              <a:ext cx="131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99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08" name="Rectangle 39">
              <a:extLst>
                <a:ext uri="{FF2B5EF4-FFF2-40B4-BE49-F238E27FC236}">
                  <a16:creationId xmlns:a16="http://schemas.microsoft.com/office/drawing/2014/main" id="{7AD09E32-0E1E-46D6-BC67-A432381AF7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0" y="2609"/>
              <a:ext cx="49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 err="1">
                  <a:solidFill>
                    <a:srgbClr val="000000"/>
                  </a:solidFill>
                </a:rPr>
                <a:t>Predicted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09" name="Line 40">
              <a:extLst>
                <a:ext uri="{FF2B5EF4-FFF2-40B4-BE49-F238E27FC236}">
                  <a16:creationId xmlns:a16="http://schemas.microsoft.com/office/drawing/2014/main" id="{E3579257-5B49-4706-BBB9-32A827D239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5" y="2687"/>
              <a:ext cx="0" cy="36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fr-FR"/>
            </a:p>
          </p:txBody>
        </p:sp>
        <p:sp>
          <p:nvSpPr>
            <p:cNvPr id="111" name="Line 42">
              <a:extLst>
                <a:ext uri="{FF2B5EF4-FFF2-40B4-BE49-F238E27FC236}">
                  <a16:creationId xmlns:a16="http://schemas.microsoft.com/office/drawing/2014/main" id="{2217DDD1-F385-4AE1-98E5-C336E4F5DB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9" y="2687"/>
              <a:ext cx="0" cy="36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fr-FR"/>
            </a:p>
          </p:txBody>
        </p:sp>
        <p:sp>
          <p:nvSpPr>
            <p:cNvPr id="113" name="Line 44">
              <a:extLst>
                <a:ext uri="{FF2B5EF4-FFF2-40B4-BE49-F238E27FC236}">
                  <a16:creationId xmlns:a16="http://schemas.microsoft.com/office/drawing/2014/main" id="{DB75E132-DEDC-499E-BCF3-38AE69754E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3" y="2805"/>
              <a:ext cx="156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fr-FR"/>
            </a:p>
          </p:txBody>
        </p:sp>
        <p:sp>
          <p:nvSpPr>
            <p:cNvPr id="115" name="Line 46">
              <a:extLst>
                <a:ext uri="{FF2B5EF4-FFF2-40B4-BE49-F238E27FC236}">
                  <a16:creationId xmlns:a16="http://schemas.microsoft.com/office/drawing/2014/main" id="{330E3668-3BB5-4DA9-9151-6243490072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3" y="3048"/>
              <a:ext cx="156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fr-FR"/>
            </a:p>
          </p:txBody>
        </p:sp>
      </p:grpSp>
      <p:grpSp>
        <p:nvGrpSpPr>
          <p:cNvPr id="150" name="Groupe 149">
            <a:extLst>
              <a:ext uri="{FF2B5EF4-FFF2-40B4-BE49-F238E27FC236}">
                <a16:creationId xmlns:a16="http://schemas.microsoft.com/office/drawing/2014/main" id="{06E1C569-3233-4C68-AC8B-4AB3B4F94A6F}"/>
              </a:ext>
            </a:extLst>
          </p:cNvPr>
          <p:cNvGrpSpPr/>
          <p:nvPr/>
        </p:nvGrpSpPr>
        <p:grpSpPr>
          <a:xfrm>
            <a:off x="3285828" y="4305489"/>
            <a:ext cx="2212235" cy="2411224"/>
            <a:chOff x="3285828" y="4051491"/>
            <a:chExt cx="2212235" cy="2834504"/>
          </a:xfrm>
        </p:grpSpPr>
        <p:grpSp>
          <p:nvGrpSpPr>
            <p:cNvPr id="119" name="Groupe 118">
              <a:extLst>
                <a:ext uri="{FF2B5EF4-FFF2-40B4-BE49-F238E27FC236}">
                  <a16:creationId xmlns:a16="http://schemas.microsoft.com/office/drawing/2014/main" id="{D5D6CEDC-40F4-4B0F-B536-292D9A1E00C3}"/>
                </a:ext>
              </a:extLst>
            </p:cNvPr>
            <p:cNvGrpSpPr/>
            <p:nvPr/>
          </p:nvGrpSpPr>
          <p:grpSpPr>
            <a:xfrm>
              <a:off x="3285828" y="4051491"/>
              <a:ext cx="1972572" cy="2834504"/>
              <a:chOff x="1253828" y="4051491"/>
              <a:chExt cx="1972572" cy="2834504"/>
            </a:xfrm>
          </p:grpSpPr>
          <p:grpSp>
            <p:nvGrpSpPr>
              <p:cNvPr id="3" name="Groupe 2">
                <a:extLst>
                  <a:ext uri="{FF2B5EF4-FFF2-40B4-BE49-F238E27FC236}">
                    <a16:creationId xmlns:a16="http://schemas.microsoft.com/office/drawing/2014/main" id="{18D815E1-D286-4199-A086-CEB41EADF628}"/>
                  </a:ext>
                </a:extLst>
              </p:cNvPr>
              <p:cNvGrpSpPr/>
              <p:nvPr/>
            </p:nvGrpSpPr>
            <p:grpSpPr>
              <a:xfrm>
                <a:off x="1253828" y="4051491"/>
                <a:ext cx="1972572" cy="2834504"/>
                <a:chOff x="7404257" y="2969280"/>
                <a:chExt cx="1972572" cy="2834504"/>
              </a:xfrm>
            </p:grpSpPr>
            <p:sp>
              <p:nvSpPr>
                <p:cNvPr id="79" name="Rectangle 76">
                  <a:extLst>
                    <a:ext uri="{FF2B5EF4-FFF2-40B4-BE49-F238E27FC236}">
                      <a16:creationId xmlns:a16="http://schemas.microsoft.com/office/drawing/2014/main" id="{054AAEC7-6712-4B6E-9AF0-6B28A089F1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913154" y="2969280"/>
                  <a:ext cx="1463675" cy="2197100"/>
                </a:xfrm>
                <a:prstGeom prst="rect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1" name="Line 38">
                  <a:extLst>
                    <a:ext uri="{FF2B5EF4-FFF2-40B4-BE49-F238E27FC236}">
                      <a16:creationId xmlns:a16="http://schemas.microsoft.com/office/drawing/2014/main" id="{B8FA78F0-ACE6-4969-B45A-AA9DF8653D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033804" y="4240867"/>
                  <a:ext cx="546100" cy="0"/>
                </a:xfrm>
                <a:prstGeom prst="line">
                  <a:avLst/>
                </a:prstGeom>
                <a:noFill/>
                <a:ln w="238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2" name="Freeform 39">
                  <a:extLst>
                    <a:ext uri="{FF2B5EF4-FFF2-40B4-BE49-F238E27FC236}">
                      <a16:creationId xmlns:a16="http://schemas.microsoft.com/office/drawing/2014/main" id="{D2D90926-F45B-4932-B75B-006F16E03399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306854" y="4699655"/>
                  <a:ext cx="0" cy="346075"/>
                </a:xfrm>
                <a:custGeom>
                  <a:avLst/>
                  <a:gdLst>
                    <a:gd name="T0" fmla="*/ 43 h 43"/>
                    <a:gd name="T1" fmla="*/ 39 h 43"/>
                    <a:gd name="T2" fmla="*/ 35 h 43"/>
                    <a:gd name="T3" fmla="*/ 31 h 43"/>
                    <a:gd name="T4" fmla="*/ 27 h 43"/>
                    <a:gd name="T5" fmla="*/ 23 h 43"/>
                    <a:gd name="T6" fmla="*/ 19 h 43"/>
                    <a:gd name="T7" fmla="*/ 15 h 43"/>
                    <a:gd name="T8" fmla="*/ 11 h 43"/>
                    <a:gd name="T9" fmla="*/ 7 h 43"/>
                    <a:gd name="T10" fmla="*/ 3 h 43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</a:cxnLst>
                  <a:rect l="0" t="0" r="r" b="b"/>
                  <a:pathLst>
                    <a:path h="43">
                      <a:moveTo>
                        <a:pt x="0" y="39"/>
                      </a:moveTo>
                      <a:lnTo>
                        <a:pt x="0" y="35"/>
                      </a:lnTo>
                      <a:moveTo>
                        <a:pt x="0" y="31"/>
                      </a:moveTo>
                      <a:lnTo>
                        <a:pt x="0" y="27"/>
                      </a:lnTo>
                      <a:moveTo>
                        <a:pt x="0" y="23"/>
                      </a:moveTo>
                      <a:lnTo>
                        <a:pt x="0" y="19"/>
                      </a:lnTo>
                      <a:moveTo>
                        <a:pt x="0" y="15"/>
                      </a:moveTo>
                      <a:lnTo>
                        <a:pt x="0" y="11"/>
                      </a:lnTo>
                      <a:moveTo>
                        <a:pt x="0" y="7"/>
                      </a:moveTo>
                      <a:lnTo>
                        <a:pt x="0" y="3"/>
                      </a:lnTo>
                    </a:path>
                  </a:pathLst>
                </a:cu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3" name="Freeform 40">
                  <a:extLst>
                    <a:ext uri="{FF2B5EF4-FFF2-40B4-BE49-F238E27FC236}">
                      <a16:creationId xmlns:a16="http://schemas.microsoft.com/office/drawing/2014/main" id="{79519D52-0DC6-45C9-BB4A-20E692EF5802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306854" y="3210580"/>
                  <a:ext cx="0" cy="660400"/>
                </a:xfrm>
                <a:custGeom>
                  <a:avLst/>
                  <a:gdLst>
                    <a:gd name="T0" fmla="*/ 0 h 82"/>
                    <a:gd name="T1" fmla="*/ 4 h 82"/>
                    <a:gd name="T2" fmla="*/ 8 h 82"/>
                    <a:gd name="T3" fmla="*/ 12 h 82"/>
                    <a:gd name="T4" fmla="*/ 16 h 82"/>
                    <a:gd name="T5" fmla="*/ 20 h 82"/>
                    <a:gd name="T6" fmla="*/ 24 h 82"/>
                    <a:gd name="T7" fmla="*/ 28 h 82"/>
                    <a:gd name="T8" fmla="*/ 32 h 82"/>
                    <a:gd name="T9" fmla="*/ 36 h 82"/>
                    <a:gd name="T10" fmla="*/ 40 h 82"/>
                    <a:gd name="T11" fmla="*/ 44 h 82"/>
                    <a:gd name="T12" fmla="*/ 48 h 82"/>
                    <a:gd name="T13" fmla="*/ 52 h 82"/>
                    <a:gd name="T14" fmla="*/ 56 h 82"/>
                    <a:gd name="T15" fmla="*/ 60 h 82"/>
                    <a:gd name="T16" fmla="*/ 64 h 82"/>
                    <a:gd name="T17" fmla="*/ 68 h 82"/>
                    <a:gd name="T18" fmla="*/ 72 h 82"/>
                    <a:gd name="T19" fmla="*/ 76 h 82"/>
                    <a:gd name="T20" fmla="*/ 80 h 82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  <a:cxn ang="0">
                      <a:pos x="0" y="T12"/>
                    </a:cxn>
                    <a:cxn ang="0">
                      <a:pos x="0" y="T13"/>
                    </a:cxn>
                    <a:cxn ang="0">
                      <a:pos x="0" y="T14"/>
                    </a:cxn>
                    <a:cxn ang="0">
                      <a:pos x="0" y="T15"/>
                    </a:cxn>
                    <a:cxn ang="0">
                      <a:pos x="0" y="T16"/>
                    </a:cxn>
                    <a:cxn ang="0">
                      <a:pos x="0" y="T17"/>
                    </a:cxn>
                    <a:cxn ang="0">
                      <a:pos x="0" y="T18"/>
                    </a:cxn>
                    <a:cxn ang="0">
                      <a:pos x="0" y="T19"/>
                    </a:cxn>
                    <a:cxn ang="0">
                      <a:pos x="0" y="T20"/>
                    </a:cxn>
                  </a:cxnLst>
                  <a:rect l="0" t="0" r="r" b="b"/>
                  <a:pathLst>
                    <a:path h="82">
                      <a:moveTo>
                        <a:pt x="0" y="4"/>
                      </a:moveTo>
                      <a:lnTo>
                        <a:pt x="0" y="8"/>
                      </a:lnTo>
                      <a:moveTo>
                        <a:pt x="0" y="12"/>
                      </a:moveTo>
                      <a:lnTo>
                        <a:pt x="0" y="16"/>
                      </a:lnTo>
                      <a:moveTo>
                        <a:pt x="0" y="20"/>
                      </a:moveTo>
                      <a:lnTo>
                        <a:pt x="0" y="24"/>
                      </a:lnTo>
                      <a:moveTo>
                        <a:pt x="0" y="28"/>
                      </a:moveTo>
                      <a:lnTo>
                        <a:pt x="0" y="32"/>
                      </a:lnTo>
                      <a:moveTo>
                        <a:pt x="0" y="36"/>
                      </a:moveTo>
                      <a:lnTo>
                        <a:pt x="0" y="40"/>
                      </a:lnTo>
                      <a:moveTo>
                        <a:pt x="0" y="44"/>
                      </a:moveTo>
                      <a:lnTo>
                        <a:pt x="0" y="48"/>
                      </a:lnTo>
                      <a:moveTo>
                        <a:pt x="0" y="52"/>
                      </a:moveTo>
                      <a:lnTo>
                        <a:pt x="0" y="56"/>
                      </a:lnTo>
                      <a:moveTo>
                        <a:pt x="0" y="60"/>
                      </a:moveTo>
                      <a:lnTo>
                        <a:pt x="0" y="64"/>
                      </a:lnTo>
                      <a:moveTo>
                        <a:pt x="0" y="68"/>
                      </a:moveTo>
                      <a:lnTo>
                        <a:pt x="0" y="72"/>
                      </a:lnTo>
                      <a:moveTo>
                        <a:pt x="0" y="76"/>
                      </a:moveTo>
                      <a:lnTo>
                        <a:pt x="0" y="80"/>
                      </a:lnTo>
                    </a:path>
                  </a:pathLst>
                </a:cu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4" name="Line 41">
                  <a:extLst>
                    <a:ext uri="{FF2B5EF4-FFF2-40B4-BE49-F238E27FC236}">
                      <a16:creationId xmlns:a16="http://schemas.microsoft.com/office/drawing/2014/main" id="{7F4F7A39-BD92-4C00-9C48-E7EADBB8C7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170329" y="5077480"/>
                  <a:ext cx="2730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5" name="Line 42">
                  <a:extLst>
                    <a:ext uri="{FF2B5EF4-FFF2-40B4-BE49-F238E27FC236}">
                      <a16:creationId xmlns:a16="http://schemas.microsoft.com/office/drawing/2014/main" id="{B4544F8C-8A66-431E-AA08-FCCB21CC64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170329" y="3178830"/>
                  <a:ext cx="2730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6" name="Rectangle 43">
                  <a:extLst>
                    <a:ext uri="{FF2B5EF4-FFF2-40B4-BE49-F238E27FC236}">
                      <a16:creationId xmlns:a16="http://schemas.microsoft.com/office/drawing/2014/main" id="{F1E3D313-89E4-4252-AABC-F8F347BB14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033804" y="3870980"/>
                  <a:ext cx="546100" cy="828675"/>
                </a:xfrm>
                <a:prstGeom prst="rect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7" name="Line 44">
                  <a:extLst>
                    <a:ext uri="{FF2B5EF4-FFF2-40B4-BE49-F238E27FC236}">
                      <a16:creationId xmlns:a16="http://schemas.microsoft.com/office/drawing/2014/main" id="{49117FBC-EFC3-4E66-992D-701AA0063F5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716429" y="3902730"/>
                  <a:ext cx="539750" cy="0"/>
                </a:xfrm>
                <a:prstGeom prst="line">
                  <a:avLst/>
                </a:prstGeom>
                <a:noFill/>
                <a:ln w="238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8" name="Freeform 45">
                  <a:extLst>
                    <a:ext uri="{FF2B5EF4-FFF2-40B4-BE49-F238E27FC236}">
                      <a16:creationId xmlns:a16="http://schemas.microsoft.com/office/drawing/2014/main" id="{68CAD653-0FF5-4968-9AE3-B267CE3621F1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981541" y="4104342"/>
                  <a:ext cx="0" cy="642938"/>
                </a:xfrm>
                <a:custGeom>
                  <a:avLst/>
                  <a:gdLst>
                    <a:gd name="T0" fmla="*/ 80 h 80"/>
                    <a:gd name="T1" fmla="*/ 76 h 80"/>
                    <a:gd name="T2" fmla="*/ 72 h 80"/>
                    <a:gd name="T3" fmla="*/ 68 h 80"/>
                    <a:gd name="T4" fmla="*/ 64 h 80"/>
                    <a:gd name="T5" fmla="*/ 60 h 80"/>
                    <a:gd name="T6" fmla="*/ 56 h 80"/>
                    <a:gd name="T7" fmla="*/ 52 h 80"/>
                    <a:gd name="T8" fmla="*/ 48 h 80"/>
                    <a:gd name="T9" fmla="*/ 44 h 80"/>
                    <a:gd name="T10" fmla="*/ 40 h 80"/>
                    <a:gd name="T11" fmla="*/ 36 h 80"/>
                    <a:gd name="T12" fmla="*/ 32 h 80"/>
                    <a:gd name="T13" fmla="*/ 28 h 80"/>
                    <a:gd name="T14" fmla="*/ 24 h 80"/>
                    <a:gd name="T15" fmla="*/ 20 h 80"/>
                    <a:gd name="T16" fmla="*/ 16 h 80"/>
                    <a:gd name="T17" fmla="*/ 12 h 80"/>
                    <a:gd name="T18" fmla="*/ 8 h 80"/>
                    <a:gd name="T19" fmla="*/ 4 h 8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  <a:cxn ang="0">
                      <a:pos x="0" y="T12"/>
                    </a:cxn>
                    <a:cxn ang="0">
                      <a:pos x="0" y="T13"/>
                    </a:cxn>
                    <a:cxn ang="0">
                      <a:pos x="0" y="T14"/>
                    </a:cxn>
                    <a:cxn ang="0">
                      <a:pos x="0" y="T15"/>
                    </a:cxn>
                    <a:cxn ang="0">
                      <a:pos x="0" y="T16"/>
                    </a:cxn>
                    <a:cxn ang="0">
                      <a:pos x="0" y="T17"/>
                    </a:cxn>
                    <a:cxn ang="0">
                      <a:pos x="0" y="T18"/>
                    </a:cxn>
                    <a:cxn ang="0">
                      <a:pos x="0" y="T19"/>
                    </a:cxn>
                  </a:cxnLst>
                  <a:rect l="0" t="0" r="r" b="b"/>
                  <a:pathLst>
                    <a:path h="80">
                      <a:moveTo>
                        <a:pt x="0" y="76"/>
                      </a:moveTo>
                      <a:lnTo>
                        <a:pt x="0" y="72"/>
                      </a:lnTo>
                      <a:moveTo>
                        <a:pt x="0" y="68"/>
                      </a:moveTo>
                      <a:lnTo>
                        <a:pt x="0" y="64"/>
                      </a:lnTo>
                      <a:moveTo>
                        <a:pt x="0" y="60"/>
                      </a:moveTo>
                      <a:lnTo>
                        <a:pt x="0" y="56"/>
                      </a:lnTo>
                      <a:moveTo>
                        <a:pt x="0" y="52"/>
                      </a:moveTo>
                      <a:lnTo>
                        <a:pt x="0" y="48"/>
                      </a:lnTo>
                      <a:moveTo>
                        <a:pt x="0" y="44"/>
                      </a:moveTo>
                      <a:lnTo>
                        <a:pt x="0" y="40"/>
                      </a:lnTo>
                      <a:moveTo>
                        <a:pt x="0" y="36"/>
                      </a:moveTo>
                      <a:lnTo>
                        <a:pt x="0" y="32"/>
                      </a:lnTo>
                      <a:moveTo>
                        <a:pt x="0" y="28"/>
                      </a:moveTo>
                      <a:lnTo>
                        <a:pt x="0" y="24"/>
                      </a:lnTo>
                      <a:moveTo>
                        <a:pt x="0" y="20"/>
                      </a:moveTo>
                      <a:lnTo>
                        <a:pt x="0" y="16"/>
                      </a:lnTo>
                      <a:moveTo>
                        <a:pt x="0" y="12"/>
                      </a:moveTo>
                      <a:lnTo>
                        <a:pt x="0" y="8"/>
                      </a:lnTo>
                      <a:moveTo>
                        <a:pt x="0" y="4"/>
                      </a:moveTo>
                    </a:path>
                  </a:pathLst>
                </a:cu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9" name="Freeform 46">
                  <a:extLst>
                    <a:ext uri="{FF2B5EF4-FFF2-40B4-BE49-F238E27FC236}">
                      <a16:creationId xmlns:a16="http://schemas.microsoft.com/office/drawing/2014/main" id="{3CE1F837-11A2-44FF-AA8C-7AFE29447F7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981541" y="3081992"/>
                  <a:ext cx="0" cy="571500"/>
                </a:xfrm>
                <a:custGeom>
                  <a:avLst/>
                  <a:gdLst>
                    <a:gd name="T0" fmla="*/ 0 h 71"/>
                    <a:gd name="T1" fmla="*/ 4 h 71"/>
                    <a:gd name="T2" fmla="*/ 8 h 71"/>
                    <a:gd name="T3" fmla="*/ 12 h 71"/>
                    <a:gd name="T4" fmla="*/ 16 h 71"/>
                    <a:gd name="T5" fmla="*/ 20 h 71"/>
                    <a:gd name="T6" fmla="*/ 24 h 71"/>
                    <a:gd name="T7" fmla="*/ 28 h 71"/>
                    <a:gd name="T8" fmla="*/ 32 h 71"/>
                    <a:gd name="T9" fmla="*/ 36 h 71"/>
                    <a:gd name="T10" fmla="*/ 40 h 71"/>
                    <a:gd name="T11" fmla="*/ 44 h 71"/>
                    <a:gd name="T12" fmla="*/ 48 h 71"/>
                    <a:gd name="T13" fmla="*/ 52 h 71"/>
                    <a:gd name="T14" fmla="*/ 56 h 71"/>
                    <a:gd name="T15" fmla="*/ 60 h 71"/>
                    <a:gd name="T16" fmla="*/ 64 h 71"/>
                    <a:gd name="T17" fmla="*/ 68 h 71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  <a:cxn ang="0">
                      <a:pos x="0" y="T12"/>
                    </a:cxn>
                    <a:cxn ang="0">
                      <a:pos x="0" y="T13"/>
                    </a:cxn>
                    <a:cxn ang="0">
                      <a:pos x="0" y="T14"/>
                    </a:cxn>
                    <a:cxn ang="0">
                      <a:pos x="0" y="T15"/>
                    </a:cxn>
                    <a:cxn ang="0">
                      <a:pos x="0" y="T16"/>
                    </a:cxn>
                    <a:cxn ang="0">
                      <a:pos x="0" y="T17"/>
                    </a:cxn>
                  </a:cxnLst>
                  <a:rect l="0" t="0" r="r" b="b"/>
                  <a:pathLst>
                    <a:path h="71">
                      <a:moveTo>
                        <a:pt x="0" y="4"/>
                      </a:moveTo>
                      <a:lnTo>
                        <a:pt x="0" y="8"/>
                      </a:lnTo>
                      <a:moveTo>
                        <a:pt x="0" y="12"/>
                      </a:moveTo>
                      <a:lnTo>
                        <a:pt x="0" y="16"/>
                      </a:lnTo>
                      <a:moveTo>
                        <a:pt x="0" y="20"/>
                      </a:moveTo>
                      <a:lnTo>
                        <a:pt x="0" y="24"/>
                      </a:lnTo>
                      <a:moveTo>
                        <a:pt x="0" y="28"/>
                      </a:moveTo>
                      <a:lnTo>
                        <a:pt x="0" y="32"/>
                      </a:lnTo>
                      <a:moveTo>
                        <a:pt x="0" y="36"/>
                      </a:moveTo>
                      <a:lnTo>
                        <a:pt x="0" y="40"/>
                      </a:lnTo>
                      <a:moveTo>
                        <a:pt x="0" y="44"/>
                      </a:moveTo>
                      <a:lnTo>
                        <a:pt x="0" y="48"/>
                      </a:lnTo>
                      <a:moveTo>
                        <a:pt x="0" y="52"/>
                      </a:moveTo>
                      <a:lnTo>
                        <a:pt x="0" y="56"/>
                      </a:lnTo>
                      <a:moveTo>
                        <a:pt x="0" y="60"/>
                      </a:moveTo>
                      <a:lnTo>
                        <a:pt x="0" y="64"/>
                      </a:lnTo>
                      <a:moveTo>
                        <a:pt x="0" y="68"/>
                      </a:moveTo>
                    </a:path>
                  </a:pathLst>
                </a:cu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0" name="Line 47">
                  <a:extLst>
                    <a:ext uri="{FF2B5EF4-FFF2-40B4-BE49-F238E27FC236}">
                      <a16:creationId xmlns:a16="http://schemas.microsoft.com/office/drawing/2014/main" id="{DD217C19-67CE-4A43-9873-52CB46E8D07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845016" y="4779030"/>
                  <a:ext cx="2730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1" name="Line 48">
                  <a:extLst>
                    <a:ext uri="{FF2B5EF4-FFF2-40B4-BE49-F238E27FC236}">
                      <a16:creationId xmlns:a16="http://schemas.microsoft.com/office/drawing/2014/main" id="{F841E9DE-D6CB-4111-BCBE-214DDB409A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845016" y="3050242"/>
                  <a:ext cx="2730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2" name="Rectangle 49">
                  <a:extLst>
                    <a:ext uri="{FF2B5EF4-FFF2-40B4-BE49-F238E27FC236}">
                      <a16:creationId xmlns:a16="http://schemas.microsoft.com/office/drawing/2014/main" id="{1E428192-BD42-4CEB-8E43-A9ECC3572A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716429" y="3653492"/>
                  <a:ext cx="539750" cy="450850"/>
                </a:xfrm>
                <a:prstGeom prst="rect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61" name="Line 58">
                  <a:extLst>
                    <a:ext uri="{FF2B5EF4-FFF2-40B4-BE49-F238E27FC236}">
                      <a16:creationId xmlns:a16="http://schemas.microsoft.com/office/drawing/2014/main" id="{FAA75094-8D36-4C8C-911E-0FF307FBA37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306854" y="5166380"/>
                  <a:ext cx="0" cy="71438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62" name="Line 59">
                  <a:extLst>
                    <a:ext uri="{FF2B5EF4-FFF2-40B4-BE49-F238E27FC236}">
                      <a16:creationId xmlns:a16="http://schemas.microsoft.com/office/drawing/2014/main" id="{4D643B48-2C12-4704-8CB1-4EDFA44D70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981541" y="5166380"/>
                  <a:ext cx="0" cy="71438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63" name="Rectangle 60">
                  <a:extLst>
                    <a:ext uri="{FF2B5EF4-FFF2-40B4-BE49-F238E27FC236}">
                      <a16:creationId xmlns:a16="http://schemas.microsoft.com/office/drawing/2014/main" id="{06927DD2-281B-41A9-87C9-5CBB0E7FFC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127326" y="5272571"/>
                  <a:ext cx="357470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low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fr-FR" altLang="fr-FR" sz="1000" dirty="0">
                      <a:solidFill>
                        <a:srgbClr val="000000"/>
                      </a:solidFill>
                    </a:rPr>
                    <a:t>n=510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4" name="Rectangle 61">
                  <a:extLst>
                    <a:ext uri="{FF2B5EF4-FFF2-40B4-BE49-F238E27FC236}">
                      <a16:creationId xmlns:a16="http://schemas.microsoft.com/office/drawing/2014/main" id="{6CF19CAB-BD91-4565-A8F2-1843BE2665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802013" y="5272571"/>
                  <a:ext cx="357470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high</a:t>
                  </a:r>
                </a:p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fr-FR" altLang="fr-FR" sz="1000" dirty="0">
                      <a:solidFill>
                        <a:srgbClr val="000000"/>
                      </a:solidFill>
                    </a:rPr>
                    <a:t>n=558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6" name="Line 63">
                  <a:extLst>
                    <a:ext uri="{FF2B5EF4-FFF2-40B4-BE49-F238E27FC236}">
                      <a16:creationId xmlns:a16="http://schemas.microsoft.com/office/drawing/2014/main" id="{6CEEACBC-0CED-4732-AAE5-D0FB97CE32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840129" y="4859992"/>
                  <a:ext cx="73025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67" name="Line 64">
                  <a:extLst>
                    <a:ext uri="{FF2B5EF4-FFF2-40B4-BE49-F238E27FC236}">
                      <a16:creationId xmlns:a16="http://schemas.microsoft.com/office/drawing/2014/main" id="{645B3D6A-7EE1-437B-80C0-3B0E774A45F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840129" y="4442480"/>
                  <a:ext cx="73025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68" name="Line 65">
                  <a:extLst>
                    <a:ext uri="{FF2B5EF4-FFF2-40B4-BE49-F238E27FC236}">
                      <a16:creationId xmlns:a16="http://schemas.microsoft.com/office/drawing/2014/main" id="{427C0403-46EC-4B7D-B8B4-39142F9986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840129" y="4031317"/>
                  <a:ext cx="73025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69" name="Line 66">
                  <a:extLst>
                    <a:ext uri="{FF2B5EF4-FFF2-40B4-BE49-F238E27FC236}">
                      <a16:creationId xmlns:a16="http://schemas.microsoft.com/office/drawing/2014/main" id="{A0DA88C6-2E4B-4AC8-8076-6B364E4852E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840129" y="3613805"/>
                  <a:ext cx="73025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70" name="Line 67">
                  <a:extLst>
                    <a:ext uri="{FF2B5EF4-FFF2-40B4-BE49-F238E27FC236}">
                      <a16:creationId xmlns:a16="http://schemas.microsoft.com/office/drawing/2014/main" id="{0BED2A7F-0D0D-41DF-A16C-A6D9086EA5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840129" y="3202642"/>
                  <a:ext cx="73025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71" name="Rectangle 68">
                  <a:extLst>
                    <a:ext uri="{FF2B5EF4-FFF2-40B4-BE49-F238E27FC236}">
                      <a16:creationId xmlns:a16="http://schemas.microsoft.com/office/drawing/2014/main" id="{87F378A1-A427-4850-B673-F64633BE93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25137" y="4804430"/>
                  <a:ext cx="219075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-0.4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2" name="Rectangle 69">
                  <a:extLst>
                    <a:ext uri="{FF2B5EF4-FFF2-40B4-BE49-F238E27FC236}">
                      <a16:creationId xmlns:a16="http://schemas.microsoft.com/office/drawing/2014/main" id="{DD0CA473-ABA3-4E64-AA36-94B9527F0B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25137" y="4393267"/>
                  <a:ext cx="219075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-0.2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3" name="Rectangle 70">
                  <a:extLst>
                    <a:ext uri="{FF2B5EF4-FFF2-40B4-BE49-F238E27FC236}">
                      <a16:creationId xmlns:a16="http://schemas.microsoft.com/office/drawing/2014/main" id="{A3729F4E-059A-4D10-9D59-0EA3A451C3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6568" y="3958503"/>
                  <a:ext cx="176213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4" name="Rectangle 71">
                  <a:extLst>
                    <a:ext uri="{FF2B5EF4-FFF2-40B4-BE49-F238E27FC236}">
                      <a16:creationId xmlns:a16="http://schemas.microsoft.com/office/drawing/2014/main" id="{79468075-CDAA-42DA-BCE5-E4099DCC9A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6568" y="3547340"/>
                  <a:ext cx="176213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2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5" name="Rectangle 72">
                  <a:extLst>
                    <a:ext uri="{FF2B5EF4-FFF2-40B4-BE49-F238E27FC236}">
                      <a16:creationId xmlns:a16="http://schemas.microsoft.com/office/drawing/2014/main" id="{3EFAACB4-2258-4C52-9097-B0B0230248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6568" y="3129828"/>
                  <a:ext cx="176213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4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7" name="Rectangle 74">
                  <a:extLst>
                    <a:ext uri="{FF2B5EF4-FFF2-40B4-BE49-F238E27FC236}">
                      <a16:creationId xmlns:a16="http://schemas.microsoft.com/office/drawing/2014/main" id="{1CAA0E53-8558-4287-89B5-63CE4C82EC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125634" y="5649896"/>
                  <a:ext cx="1035540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observed</a:t>
                  </a:r>
                  <a:r>
                    <a:rPr kumimoji="0" lang="fr-FR" altLang="fr-FR" sz="10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CSPG4</a:t>
                  </a:r>
                  <a:endParaRPr kumimoji="0" lang="fr-FR" altLang="fr-FR" sz="1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8" name="Rectangle 75">
                  <a:extLst>
                    <a:ext uri="{FF2B5EF4-FFF2-40B4-BE49-F238E27FC236}">
                      <a16:creationId xmlns:a16="http://schemas.microsoft.com/office/drawing/2014/main" id="{555C22AC-0A64-4464-9A2F-251039D549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938584" y="3985330"/>
                  <a:ext cx="1085233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score (Pearson, r)</a:t>
                  </a:r>
                  <a:endParaRPr kumimoji="0" lang="fr-FR" altLang="fr-FR" sz="1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0" name="Rectangle 77">
                  <a:extLst>
                    <a:ext uri="{FF2B5EF4-FFF2-40B4-BE49-F238E27FC236}">
                      <a16:creationId xmlns:a16="http://schemas.microsoft.com/office/drawing/2014/main" id="{97A33EAA-A792-4D66-B7A8-EB9C92DA12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354755" y="3279604"/>
                  <a:ext cx="599523" cy="16281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=9.33E-44</a:t>
                  </a:r>
                  <a:endParaRPr kumimoji="0" lang="fr-FR" altLang="fr-FR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cxnSp>
            <p:nvCxnSpPr>
              <p:cNvPr id="118" name="Connecteur droit 117">
                <a:extLst>
                  <a:ext uri="{FF2B5EF4-FFF2-40B4-BE49-F238E27FC236}">
                    <a16:creationId xmlns:a16="http://schemas.microsoft.com/office/drawing/2014/main" id="{FBB131E7-27F8-428E-B5FC-7E0EB287AA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62725" y="5113528"/>
                <a:ext cx="1463675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6" name="Groupe 125">
              <a:extLst>
                <a:ext uri="{FF2B5EF4-FFF2-40B4-BE49-F238E27FC236}">
                  <a16:creationId xmlns:a16="http://schemas.microsoft.com/office/drawing/2014/main" id="{9FF1C611-FA49-44B4-BF4D-82A0F7DEBB44}"/>
                </a:ext>
              </a:extLst>
            </p:cNvPr>
            <p:cNvGrpSpPr/>
            <p:nvPr/>
          </p:nvGrpSpPr>
          <p:grpSpPr>
            <a:xfrm>
              <a:off x="5314950" y="4337050"/>
              <a:ext cx="183113" cy="1577250"/>
              <a:chOff x="3308350" y="4279900"/>
              <a:chExt cx="183113" cy="1577250"/>
            </a:xfrm>
          </p:grpSpPr>
          <p:sp>
            <p:nvSpPr>
              <p:cNvPr id="120" name="Rectangle 61">
                <a:extLst>
                  <a:ext uri="{FF2B5EF4-FFF2-40B4-BE49-F238E27FC236}">
                    <a16:creationId xmlns:a16="http://schemas.microsoft.com/office/drawing/2014/main" id="{BC68794C-F52A-4962-8158-0F15E97B60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235784" y="4624578"/>
                <a:ext cx="35747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latin typeface="Arial" panose="020B0604020202020204" pitchFamily="34" charset="0"/>
                  </a:rPr>
                  <a:t>high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1" name="Rectangle 61">
                <a:extLst>
                  <a:ext uri="{FF2B5EF4-FFF2-40B4-BE49-F238E27FC236}">
                    <a16:creationId xmlns:a16="http://schemas.microsoft.com/office/drawing/2014/main" id="{4403AA3F-09C2-48A4-A9C5-3448DDECE5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235784" y="5411978"/>
                <a:ext cx="35747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 err="1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latin typeface="Arial" panose="020B0604020202020204" pitchFamily="34" charset="0"/>
                  </a:rPr>
                  <a:t>low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cxnSp>
            <p:nvCxnSpPr>
              <p:cNvPr id="123" name="Connecteur droit avec flèche 122">
                <a:extLst>
                  <a:ext uri="{FF2B5EF4-FFF2-40B4-BE49-F238E27FC236}">
                    <a16:creationId xmlns:a16="http://schemas.microsoft.com/office/drawing/2014/main" id="{55665BCF-3C6F-4200-A72E-FA6A8C0BF43C}"/>
                  </a:ext>
                </a:extLst>
              </p:cNvPr>
              <p:cNvCxnSpPr/>
              <p:nvPr/>
            </p:nvCxnSpPr>
            <p:spPr>
              <a:xfrm flipV="1">
                <a:off x="3308350" y="4279900"/>
                <a:ext cx="0" cy="720000"/>
              </a:xfrm>
              <a:prstGeom prst="straightConnector1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sys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necteur droit avec flèche 123">
                <a:extLst>
                  <a:ext uri="{FF2B5EF4-FFF2-40B4-BE49-F238E27FC236}">
                    <a16:creationId xmlns:a16="http://schemas.microsoft.com/office/drawing/2014/main" id="{E3703490-487D-442B-A8D5-1ED9D80A79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08350" y="5137150"/>
                <a:ext cx="0" cy="720000"/>
              </a:xfrm>
              <a:prstGeom prst="straightConnector1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sys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9" name="Groupe 148">
            <a:extLst>
              <a:ext uri="{FF2B5EF4-FFF2-40B4-BE49-F238E27FC236}">
                <a16:creationId xmlns:a16="http://schemas.microsoft.com/office/drawing/2014/main" id="{895BB791-D289-48CB-B9E6-312D3983C429}"/>
              </a:ext>
            </a:extLst>
          </p:cNvPr>
          <p:cNvGrpSpPr/>
          <p:nvPr/>
        </p:nvGrpSpPr>
        <p:grpSpPr>
          <a:xfrm>
            <a:off x="4473508" y="926391"/>
            <a:ext cx="2211210" cy="2387409"/>
            <a:chOff x="4537008" y="846561"/>
            <a:chExt cx="2211210" cy="2806509"/>
          </a:xfrm>
        </p:grpSpPr>
        <p:grpSp>
          <p:nvGrpSpPr>
            <p:cNvPr id="117" name="Groupe 116">
              <a:extLst>
                <a:ext uri="{FF2B5EF4-FFF2-40B4-BE49-F238E27FC236}">
                  <a16:creationId xmlns:a16="http://schemas.microsoft.com/office/drawing/2014/main" id="{94963315-BE91-44EC-A394-0704331312ED}"/>
                </a:ext>
              </a:extLst>
            </p:cNvPr>
            <p:cNvGrpSpPr/>
            <p:nvPr/>
          </p:nvGrpSpPr>
          <p:grpSpPr>
            <a:xfrm>
              <a:off x="4537008" y="846561"/>
              <a:ext cx="1972571" cy="2806509"/>
              <a:chOff x="4537008" y="846561"/>
              <a:chExt cx="1972571" cy="2806509"/>
            </a:xfrm>
          </p:grpSpPr>
          <p:grpSp>
            <p:nvGrpSpPr>
              <p:cNvPr id="2" name="Groupe 1">
                <a:extLst>
                  <a:ext uri="{FF2B5EF4-FFF2-40B4-BE49-F238E27FC236}">
                    <a16:creationId xmlns:a16="http://schemas.microsoft.com/office/drawing/2014/main" id="{5F5C2681-A5ED-47A2-9ED3-7689D0B15262}"/>
                  </a:ext>
                </a:extLst>
              </p:cNvPr>
              <p:cNvGrpSpPr/>
              <p:nvPr/>
            </p:nvGrpSpPr>
            <p:grpSpPr>
              <a:xfrm>
                <a:off x="4537008" y="846561"/>
                <a:ext cx="1972571" cy="2806509"/>
                <a:chOff x="4983320" y="2969280"/>
                <a:chExt cx="1972571" cy="2806509"/>
              </a:xfrm>
            </p:grpSpPr>
            <p:sp>
              <p:nvSpPr>
                <p:cNvPr id="39" name="Rectangle 36">
                  <a:extLst>
                    <a:ext uri="{FF2B5EF4-FFF2-40B4-BE49-F238E27FC236}">
                      <a16:creationId xmlns:a16="http://schemas.microsoft.com/office/drawing/2014/main" id="{51B12932-AD68-488A-95F4-A7BDA02BBA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92216" y="2969280"/>
                  <a:ext cx="1463675" cy="2197100"/>
                </a:xfrm>
                <a:prstGeom prst="rect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8" name="Line 5">
                  <a:extLst>
                    <a:ext uri="{FF2B5EF4-FFF2-40B4-BE49-F238E27FC236}">
                      <a16:creationId xmlns:a16="http://schemas.microsoft.com/office/drawing/2014/main" id="{FC68CAA2-2944-4BDD-B183-5C3E0CDA2C7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12866" y="4329767"/>
                  <a:ext cx="547688" cy="0"/>
                </a:xfrm>
                <a:prstGeom prst="line">
                  <a:avLst/>
                </a:prstGeom>
                <a:noFill/>
                <a:ln w="238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9" name="Freeform 6">
                  <a:extLst>
                    <a:ext uri="{FF2B5EF4-FFF2-40B4-BE49-F238E27FC236}">
                      <a16:creationId xmlns:a16="http://schemas.microsoft.com/office/drawing/2014/main" id="{FA13202A-F086-4902-BD80-C05EE48D465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5885916" y="4747280"/>
                  <a:ext cx="0" cy="298450"/>
                </a:xfrm>
                <a:custGeom>
                  <a:avLst/>
                  <a:gdLst>
                    <a:gd name="T0" fmla="*/ 37 h 37"/>
                    <a:gd name="T1" fmla="*/ 33 h 37"/>
                    <a:gd name="T2" fmla="*/ 29 h 37"/>
                    <a:gd name="T3" fmla="*/ 25 h 37"/>
                    <a:gd name="T4" fmla="*/ 21 h 37"/>
                    <a:gd name="T5" fmla="*/ 17 h 37"/>
                    <a:gd name="T6" fmla="*/ 13 h 37"/>
                    <a:gd name="T7" fmla="*/ 9 h 37"/>
                    <a:gd name="T8" fmla="*/ 5 h 37"/>
                    <a:gd name="T9" fmla="*/ 1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</a:cxnLst>
                  <a:rect l="0" t="0" r="r" b="b"/>
                  <a:pathLst>
                    <a:path h="37">
                      <a:moveTo>
                        <a:pt x="0" y="33"/>
                      </a:moveTo>
                      <a:lnTo>
                        <a:pt x="0" y="29"/>
                      </a:lnTo>
                      <a:moveTo>
                        <a:pt x="0" y="25"/>
                      </a:moveTo>
                      <a:lnTo>
                        <a:pt x="0" y="21"/>
                      </a:lnTo>
                      <a:moveTo>
                        <a:pt x="0" y="17"/>
                      </a:moveTo>
                      <a:lnTo>
                        <a:pt x="0" y="13"/>
                      </a:lnTo>
                      <a:moveTo>
                        <a:pt x="0" y="9"/>
                      </a:moveTo>
                      <a:lnTo>
                        <a:pt x="0" y="5"/>
                      </a:lnTo>
                      <a:moveTo>
                        <a:pt x="0" y="1"/>
                      </a:moveTo>
                    </a:path>
                  </a:pathLst>
                </a:cu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0" name="Freeform 7">
                  <a:extLst>
                    <a:ext uri="{FF2B5EF4-FFF2-40B4-BE49-F238E27FC236}">
                      <a16:creationId xmlns:a16="http://schemas.microsoft.com/office/drawing/2014/main" id="{C4BA127B-BB9C-4F7C-A4D6-B6E82F507151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5885916" y="3155017"/>
                  <a:ext cx="0" cy="892175"/>
                </a:xfrm>
                <a:custGeom>
                  <a:avLst/>
                  <a:gdLst>
                    <a:gd name="T0" fmla="*/ 0 h 111"/>
                    <a:gd name="T1" fmla="*/ 4 h 111"/>
                    <a:gd name="T2" fmla="*/ 8 h 111"/>
                    <a:gd name="T3" fmla="*/ 12 h 111"/>
                    <a:gd name="T4" fmla="*/ 16 h 111"/>
                    <a:gd name="T5" fmla="*/ 20 h 111"/>
                    <a:gd name="T6" fmla="*/ 24 h 111"/>
                    <a:gd name="T7" fmla="*/ 28 h 111"/>
                    <a:gd name="T8" fmla="*/ 32 h 111"/>
                    <a:gd name="T9" fmla="*/ 36 h 111"/>
                    <a:gd name="T10" fmla="*/ 40 h 111"/>
                    <a:gd name="T11" fmla="*/ 44 h 111"/>
                    <a:gd name="T12" fmla="*/ 48 h 111"/>
                    <a:gd name="T13" fmla="*/ 52 h 111"/>
                    <a:gd name="T14" fmla="*/ 56 h 111"/>
                    <a:gd name="T15" fmla="*/ 60 h 111"/>
                    <a:gd name="T16" fmla="*/ 64 h 111"/>
                    <a:gd name="T17" fmla="*/ 68 h 111"/>
                    <a:gd name="T18" fmla="*/ 72 h 111"/>
                    <a:gd name="T19" fmla="*/ 76 h 111"/>
                    <a:gd name="T20" fmla="*/ 80 h 111"/>
                    <a:gd name="T21" fmla="*/ 84 h 111"/>
                    <a:gd name="T22" fmla="*/ 88 h 111"/>
                    <a:gd name="T23" fmla="*/ 92 h 111"/>
                    <a:gd name="T24" fmla="*/ 96 h 111"/>
                    <a:gd name="T25" fmla="*/ 100 h 111"/>
                    <a:gd name="T26" fmla="*/ 104 h 111"/>
                    <a:gd name="T27" fmla="*/ 108 h 111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  <a:cxn ang="0">
                      <a:pos x="0" y="T12"/>
                    </a:cxn>
                    <a:cxn ang="0">
                      <a:pos x="0" y="T13"/>
                    </a:cxn>
                    <a:cxn ang="0">
                      <a:pos x="0" y="T14"/>
                    </a:cxn>
                    <a:cxn ang="0">
                      <a:pos x="0" y="T15"/>
                    </a:cxn>
                    <a:cxn ang="0">
                      <a:pos x="0" y="T16"/>
                    </a:cxn>
                    <a:cxn ang="0">
                      <a:pos x="0" y="T17"/>
                    </a:cxn>
                    <a:cxn ang="0">
                      <a:pos x="0" y="T18"/>
                    </a:cxn>
                    <a:cxn ang="0">
                      <a:pos x="0" y="T19"/>
                    </a:cxn>
                    <a:cxn ang="0">
                      <a:pos x="0" y="T20"/>
                    </a:cxn>
                    <a:cxn ang="0">
                      <a:pos x="0" y="T21"/>
                    </a:cxn>
                    <a:cxn ang="0">
                      <a:pos x="0" y="T22"/>
                    </a:cxn>
                    <a:cxn ang="0">
                      <a:pos x="0" y="T23"/>
                    </a:cxn>
                    <a:cxn ang="0">
                      <a:pos x="0" y="T24"/>
                    </a:cxn>
                    <a:cxn ang="0">
                      <a:pos x="0" y="T25"/>
                    </a:cxn>
                    <a:cxn ang="0">
                      <a:pos x="0" y="T26"/>
                    </a:cxn>
                    <a:cxn ang="0">
                      <a:pos x="0" y="T27"/>
                    </a:cxn>
                  </a:cxnLst>
                  <a:rect l="0" t="0" r="r" b="b"/>
                  <a:pathLst>
                    <a:path h="111">
                      <a:moveTo>
                        <a:pt x="0" y="4"/>
                      </a:moveTo>
                      <a:lnTo>
                        <a:pt x="0" y="8"/>
                      </a:lnTo>
                      <a:moveTo>
                        <a:pt x="0" y="12"/>
                      </a:moveTo>
                      <a:lnTo>
                        <a:pt x="0" y="16"/>
                      </a:lnTo>
                      <a:moveTo>
                        <a:pt x="0" y="20"/>
                      </a:moveTo>
                      <a:lnTo>
                        <a:pt x="0" y="24"/>
                      </a:lnTo>
                      <a:moveTo>
                        <a:pt x="0" y="28"/>
                      </a:moveTo>
                      <a:lnTo>
                        <a:pt x="0" y="32"/>
                      </a:lnTo>
                      <a:moveTo>
                        <a:pt x="0" y="36"/>
                      </a:moveTo>
                      <a:lnTo>
                        <a:pt x="0" y="40"/>
                      </a:lnTo>
                      <a:moveTo>
                        <a:pt x="0" y="44"/>
                      </a:moveTo>
                      <a:lnTo>
                        <a:pt x="0" y="48"/>
                      </a:lnTo>
                      <a:moveTo>
                        <a:pt x="0" y="52"/>
                      </a:moveTo>
                      <a:lnTo>
                        <a:pt x="0" y="56"/>
                      </a:lnTo>
                      <a:moveTo>
                        <a:pt x="0" y="60"/>
                      </a:moveTo>
                      <a:lnTo>
                        <a:pt x="0" y="64"/>
                      </a:lnTo>
                      <a:moveTo>
                        <a:pt x="0" y="68"/>
                      </a:moveTo>
                      <a:lnTo>
                        <a:pt x="0" y="72"/>
                      </a:lnTo>
                      <a:moveTo>
                        <a:pt x="0" y="76"/>
                      </a:moveTo>
                      <a:lnTo>
                        <a:pt x="0" y="80"/>
                      </a:lnTo>
                      <a:moveTo>
                        <a:pt x="0" y="84"/>
                      </a:moveTo>
                      <a:lnTo>
                        <a:pt x="0" y="88"/>
                      </a:lnTo>
                      <a:moveTo>
                        <a:pt x="0" y="92"/>
                      </a:moveTo>
                      <a:lnTo>
                        <a:pt x="0" y="96"/>
                      </a:lnTo>
                      <a:moveTo>
                        <a:pt x="0" y="100"/>
                      </a:moveTo>
                      <a:lnTo>
                        <a:pt x="0" y="104"/>
                      </a:lnTo>
                      <a:moveTo>
                        <a:pt x="0" y="108"/>
                      </a:moveTo>
                    </a:path>
                  </a:pathLst>
                </a:cu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" name="Line 8">
                  <a:extLst>
                    <a:ext uri="{FF2B5EF4-FFF2-40B4-BE49-F238E27FC236}">
                      <a16:creationId xmlns:a16="http://schemas.microsoft.com/office/drawing/2014/main" id="{345F79F0-67D8-4276-8966-532810A0E9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49391" y="5077480"/>
                  <a:ext cx="2730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" name="Line 9">
                  <a:extLst>
                    <a:ext uri="{FF2B5EF4-FFF2-40B4-BE49-F238E27FC236}">
                      <a16:creationId xmlns:a16="http://schemas.microsoft.com/office/drawing/2014/main" id="{01B92F39-FAC0-45F5-AF0E-628B5E9628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49391" y="3123267"/>
                  <a:ext cx="2730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3" name="Rectangle 10">
                  <a:extLst>
                    <a:ext uri="{FF2B5EF4-FFF2-40B4-BE49-F238E27FC236}">
                      <a16:creationId xmlns:a16="http://schemas.microsoft.com/office/drawing/2014/main" id="{3F932916-CBFD-46A1-8215-0139A13A69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612866" y="4047192"/>
                  <a:ext cx="547688" cy="700088"/>
                </a:xfrm>
                <a:prstGeom prst="rect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4" name="Line 11">
                  <a:extLst>
                    <a:ext uri="{FF2B5EF4-FFF2-40B4-BE49-F238E27FC236}">
                      <a16:creationId xmlns:a16="http://schemas.microsoft.com/office/drawing/2014/main" id="{CC26A91E-BA5B-48E9-BD1B-0EBAF6E7E8E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97079" y="3750330"/>
                  <a:ext cx="538163" cy="0"/>
                </a:xfrm>
                <a:prstGeom prst="line">
                  <a:avLst/>
                </a:prstGeom>
                <a:noFill/>
                <a:ln w="238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5" name="Freeform 12">
                  <a:extLst>
                    <a:ext uri="{FF2B5EF4-FFF2-40B4-BE49-F238E27FC236}">
                      <a16:creationId xmlns:a16="http://schemas.microsoft.com/office/drawing/2014/main" id="{AC31E968-7713-4252-A23B-40B85FC2379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6562191" y="3975755"/>
                  <a:ext cx="0" cy="787400"/>
                </a:xfrm>
                <a:custGeom>
                  <a:avLst/>
                  <a:gdLst>
                    <a:gd name="T0" fmla="*/ 98 h 98"/>
                    <a:gd name="T1" fmla="*/ 94 h 98"/>
                    <a:gd name="T2" fmla="*/ 90 h 98"/>
                    <a:gd name="T3" fmla="*/ 86 h 98"/>
                    <a:gd name="T4" fmla="*/ 82 h 98"/>
                    <a:gd name="T5" fmla="*/ 78 h 98"/>
                    <a:gd name="T6" fmla="*/ 74 h 98"/>
                    <a:gd name="T7" fmla="*/ 70 h 98"/>
                    <a:gd name="T8" fmla="*/ 66 h 98"/>
                    <a:gd name="T9" fmla="*/ 62 h 98"/>
                    <a:gd name="T10" fmla="*/ 58 h 98"/>
                    <a:gd name="T11" fmla="*/ 54 h 98"/>
                    <a:gd name="T12" fmla="*/ 50 h 98"/>
                    <a:gd name="T13" fmla="*/ 46 h 98"/>
                    <a:gd name="T14" fmla="*/ 42 h 98"/>
                    <a:gd name="T15" fmla="*/ 38 h 98"/>
                    <a:gd name="T16" fmla="*/ 34 h 98"/>
                    <a:gd name="T17" fmla="*/ 30 h 98"/>
                    <a:gd name="T18" fmla="*/ 26 h 98"/>
                    <a:gd name="T19" fmla="*/ 22 h 98"/>
                    <a:gd name="T20" fmla="*/ 18 h 98"/>
                    <a:gd name="T21" fmla="*/ 14 h 98"/>
                    <a:gd name="T22" fmla="*/ 10 h 98"/>
                    <a:gd name="T23" fmla="*/ 6 h 98"/>
                    <a:gd name="T24" fmla="*/ 2 h 98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  <a:cxn ang="0">
                      <a:pos x="0" y="T12"/>
                    </a:cxn>
                    <a:cxn ang="0">
                      <a:pos x="0" y="T13"/>
                    </a:cxn>
                    <a:cxn ang="0">
                      <a:pos x="0" y="T14"/>
                    </a:cxn>
                    <a:cxn ang="0">
                      <a:pos x="0" y="T15"/>
                    </a:cxn>
                    <a:cxn ang="0">
                      <a:pos x="0" y="T16"/>
                    </a:cxn>
                    <a:cxn ang="0">
                      <a:pos x="0" y="T17"/>
                    </a:cxn>
                    <a:cxn ang="0">
                      <a:pos x="0" y="T18"/>
                    </a:cxn>
                    <a:cxn ang="0">
                      <a:pos x="0" y="T19"/>
                    </a:cxn>
                    <a:cxn ang="0">
                      <a:pos x="0" y="T20"/>
                    </a:cxn>
                    <a:cxn ang="0">
                      <a:pos x="0" y="T21"/>
                    </a:cxn>
                    <a:cxn ang="0">
                      <a:pos x="0" y="T22"/>
                    </a:cxn>
                    <a:cxn ang="0">
                      <a:pos x="0" y="T23"/>
                    </a:cxn>
                    <a:cxn ang="0">
                      <a:pos x="0" y="T24"/>
                    </a:cxn>
                  </a:cxnLst>
                  <a:rect l="0" t="0" r="r" b="b"/>
                  <a:pathLst>
                    <a:path h="98">
                      <a:moveTo>
                        <a:pt x="0" y="94"/>
                      </a:moveTo>
                      <a:lnTo>
                        <a:pt x="0" y="90"/>
                      </a:lnTo>
                      <a:moveTo>
                        <a:pt x="0" y="86"/>
                      </a:moveTo>
                      <a:lnTo>
                        <a:pt x="0" y="82"/>
                      </a:lnTo>
                      <a:moveTo>
                        <a:pt x="0" y="78"/>
                      </a:moveTo>
                      <a:lnTo>
                        <a:pt x="0" y="74"/>
                      </a:lnTo>
                      <a:moveTo>
                        <a:pt x="0" y="70"/>
                      </a:moveTo>
                      <a:lnTo>
                        <a:pt x="0" y="66"/>
                      </a:lnTo>
                      <a:moveTo>
                        <a:pt x="0" y="62"/>
                      </a:moveTo>
                      <a:lnTo>
                        <a:pt x="0" y="58"/>
                      </a:lnTo>
                      <a:moveTo>
                        <a:pt x="0" y="54"/>
                      </a:moveTo>
                      <a:lnTo>
                        <a:pt x="0" y="50"/>
                      </a:lnTo>
                      <a:moveTo>
                        <a:pt x="0" y="46"/>
                      </a:moveTo>
                      <a:lnTo>
                        <a:pt x="0" y="42"/>
                      </a:lnTo>
                      <a:moveTo>
                        <a:pt x="0" y="38"/>
                      </a:moveTo>
                      <a:lnTo>
                        <a:pt x="0" y="34"/>
                      </a:lnTo>
                      <a:moveTo>
                        <a:pt x="0" y="30"/>
                      </a:moveTo>
                      <a:lnTo>
                        <a:pt x="0" y="26"/>
                      </a:lnTo>
                      <a:moveTo>
                        <a:pt x="0" y="22"/>
                      </a:moveTo>
                      <a:lnTo>
                        <a:pt x="0" y="18"/>
                      </a:lnTo>
                      <a:moveTo>
                        <a:pt x="0" y="14"/>
                      </a:moveTo>
                      <a:lnTo>
                        <a:pt x="0" y="10"/>
                      </a:lnTo>
                      <a:moveTo>
                        <a:pt x="0" y="6"/>
                      </a:moveTo>
                      <a:lnTo>
                        <a:pt x="0" y="2"/>
                      </a:lnTo>
                    </a:path>
                  </a:pathLst>
                </a:cu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6" name="Freeform 13">
                  <a:extLst>
                    <a:ext uri="{FF2B5EF4-FFF2-40B4-BE49-F238E27FC236}">
                      <a16:creationId xmlns:a16="http://schemas.microsoft.com/office/drawing/2014/main" id="{E8067413-A076-4D55-8BBA-2AE769E2F441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6562191" y="3081992"/>
                  <a:ext cx="0" cy="322263"/>
                </a:xfrm>
                <a:custGeom>
                  <a:avLst/>
                  <a:gdLst>
                    <a:gd name="T0" fmla="*/ 0 h 40"/>
                    <a:gd name="T1" fmla="*/ 4 h 40"/>
                    <a:gd name="T2" fmla="*/ 8 h 40"/>
                    <a:gd name="T3" fmla="*/ 12 h 40"/>
                    <a:gd name="T4" fmla="*/ 16 h 40"/>
                    <a:gd name="T5" fmla="*/ 20 h 40"/>
                    <a:gd name="T6" fmla="*/ 24 h 40"/>
                    <a:gd name="T7" fmla="*/ 28 h 40"/>
                    <a:gd name="T8" fmla="*/ 32 h 40"/>
                    <a:gd name="T9" fmla="*/ 36 h 4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</a:cxnLst>
                  <a:rect l="0" t="0" r="r" b="b"/>
                  <a:pathLst>
                    <a:path h="40">
                      <a:moveTo>
                        <a:pt x="0" y="4"/>
                      </a:moveTo>
                      <a:lnTo>
                        <a:pt x="0" y="8"/>
                      </a:lnTo>
                      <a:moveTo>
                        <a:pt x="0" y="12"/>
                      </a:moveTo>
                      <a:lnTo>
                        <a:pt x="0" y="16"/>
                      </a:lnTo>
                      <a:moveTo>
                        <a:pt x="0" y="20"/>
                      </a:moveTo>
                      <a:lnTo>
                        <a:pt x="0" y="24"/>
                      </a:lnTo>
                      <a:moveTo>
                        <a:pt x="0" y="28"/>
                      </a:moveTo>
                      <a:lnTo>
                        <a:pt x="0" y="32"/>
                      </a:lnTo>
                      <a:moveTo>
                        <a:pt x="0" y="36"/>
                      </a:moveTo>
                    </a:path>
                  </a:pathLst>
                </a:cu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7" name="Line 14">
                  <a:extLst>
                    <a:ext uri="{FF2B5EF4-FFF2-40B4-BE49-F238E27FC236}">
                      <a16:creationId xmlns:a16="http://schemas.microsoft.com/office/drawing/2014/main" id="{08FCDE42-CB94-4755-B1E7-AB413D2E18E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425666" y="4796492"/>
                  <a:ext cx="2730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" name="Line 15">
                  <a:extLst>
                    <a:ext uri="{FF2B5EF4-FFF2-40B4-BE49-F238E27FC236}">
                      <a16:creationId xmlns:a16="http://schemas.microsoft.com/office/drawing/2014/main" id="{BAF70A04-0956-42BA-B79A-34D5E75C6D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425666" y="3050242"/>
                  <a:ext cx="2730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9" name="Rectangle 16">
                  <a:extLst>
                    <a:ext uri="{FF2B5EF4-FFF2-40B4-BE49-F238E27FC236}">
                      <a16:creationId xmlns:a16="http://schemas.microsoft.com/office/drawing/2014/main" id="{28E9A650-FEF9-446F-97C7-B1BE2A8C67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97079" y="3404255"/>
                  <a:ext cx="538163" cy="571500"/>
                </a:xfrm>
                <a:prstGeom prst="rect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" name="Line 18">
                  <a:extLst>
                    <a:ext uri="{FF2B5EF4-FFF2-40B4-BE49-F238E27FC236}">
                      <a16:creationId xmlns:a16="http://schemas.microsoft.com/office/drawing/2014/main" id="{78A387B5-5550-4362-B5FD-788502CD831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885916" y="5166380"/>
                  <a:ext cx="0" cy="71438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2" name="Line 19">
                  <a:extLst>
                    <a:ext uri="{FF2B5EF4-FFF2-40B4-BE49-F238E27FC236}">
                      <a16:creationId xmlns:a16="http://schemas.microsoft.com/office/drawing/2014/main" id="{5C4881C1-69FC-47EA-AE31-8E1C3CA0594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62191" y="5166380"/>
                  <a:ext cx="0" cy="71438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" name="Rectangle 20">
                  <a:extLst>
                    <a:ext uri="{FF2B5EF4-FFF2-40B4-BE49-F238E27FC236}">
                      <a16:creationId xmlns:a16="http://schemas.microsoft.com/office/drawing/2014/main" id="{8A12FC25-C274-4E3E-847A-339A5236D40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08768" y="5269776"/>
                  <a:ext cx="357470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low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fr-FR" altLang="fr-FR" sz="1000" dirty="0">
                      <a:solidFill>
                        <a:srgbClr val="000000"/>
                      </a:solidFill>
                    </a:rPr>
                    <a:t>n=179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" name="Rectangle 21">
                  <a:extLst>
                    <a:ext uri="{FF2B5EF4-FFF2-40B4-BE49-F238E27FC236}">
                      <a16:creationId xmlns:a16="http://schemas.microsoft.com/office/drawing/2014/main" id="{5F65AEA5-EF12-422B-98EC-B675A48AF2D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85044" y="5269776"/>
                  <a:ext cx="357470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high</a:t>
                  </a:r>
                </a:p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fr-FR" altLang="fr-FR" sz="1000" dirty="0">
                      <a:solidFill>
                        <a:srgbClr val="000000"/>
                      </a:solidFill>
                    </a:rPr>
                    <a:t>n=131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" name="Line 23">
                  <a:extLst>
                    <a:ext uri="{FF2B5EF4-FFF2-40B4-BE49-F238E27FC236}">
                      <a16:creationId xmlns:a16="http://schemas.microsoft.com/office/drawing/2014/main" id="{87996BC9-2BA5-455E-9D8D-D26C23F49B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420779" y="4844117"/>
                  <a:ext cx="71438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7" name="Line 24">
                  <a:extLst>
                    <a:ext uri="{FF2B5EF4-FFF2-40B4-BE49-F238E27FC236}">
                      <a16:creationId xmlns:a16="http://schemas.microsoft.com/office/drawing/2014/main" id="{FF660948-456C-4731-BF71-364C02CECD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420779" y="4434542"/>
                  <a:ext cx="71438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8" name="Line 25">
                  <a:extLst>
                    <a:ext uri="{FF2B5EF4-FFF2-40B4-BE49-F238E27FC236}">
                      <a16:creationId xmlns:a16="http://schemas.microsoft.com/office/drawing/2014/main" id="{366E0228-8822-4C34-A9DE-6CC5639AC3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420779" y="4031317"/>
                  <a:ext cx="71438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9" name="Line 26">
                  <a:extLst>
                    <a:ext uri="{FF2B5EF4-FFF2-40B4-BE49-F238E27FC236}">
                      <a16:creationId xmlns:a16="http://schemas.microsoft.com/office/drawing/2014/main" id="{935F5EF3-9595-4FBC-8573-DBE6B9699F2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420779" y="3621742"/>
                  <a:ext cx="71438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0" name="Line 27">
                  <a:extLst>
                    <a:ext uri="{FF2B5EF4-FFF2-40B4-BE49-F238E27FC236}">
                      <a16:creationId xmlns:a16="http://schemas.microsoft.com/office/drawing/2014/main" id="{49618653-06ED-4FA5-9549-4CA986168AE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420779" y="3210580"/>
                  <a:ext cx="71438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1" name="Rectangle 28">
                  <a:extLst>
                    <a:ext uri="{FF2B5EF4-FFF2-40B4-BE49-F238E27FC236}">
                      <a16:creationId xmlns:a16="http://schemas.microsoft.com/office/drawing/2014/main" id="{70BA36DE-7056-4C35-8C64-D83567AFEE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89328" y="4779240"/>
                  <a:ext cx="219075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-0.4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" name="Rectangle 29">
                  <a:extLst>
                    <a:ext uri="{FF2B5EF4-FFF2-40B4-BE49-F238E27FC236}">
                      <a16:creationId xmlns:a16="http://schemas.microsoft.com/office/drawing/2014/main" id="{190CC70D-6CDF-488F-AE3D-A1209C7FBB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89328" y="4368078"/>
                  <a:ext cx="219075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-0.2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3" name="Rectangle 30">
                  <a:extLst>
                    <a:ext uri="{FF2B5EF4-FFF2-40B4-BE49-F238E27FC236}">
                      <a16:creationId xmlns:a16="http://schemas.microsoft.com/office/drawing/2014/main" id="{D8F1DFB0-2E90-4438-9DCA-2870466376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30603" y="3958503"/>
                  <a:ext cx="176213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" name="Rectangle 31">
                  <a:extLst>
                    <a:ext uri="{FF2B5EF4-FFF2-40B4-BE49-F238E27FC236}">
                      <a16:creationId xmlns:a16="http://schemas.microsoft.com/office/drawing/2014/main" id="{B47E5269-3231-4F50-8581-1E6CB9F0B7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30603" y="3547340"/>
                  <a:ext cx="176213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2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" name="Rectangle 32">
                  <a:extLst>
                    <a:ext uri="{FF2B5EF4-FFF2-40B4-BE49-F238E27FC236}">
                      <a16:creationId xmlns:a16="http://schemas.microsoft.com/office/drawing/2014/main" id="{03D1DD7D-F15A-4C0D-AAB1-BF71E46517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30603" y="3145703"/>
                  <a:ext cx="176213" cy="153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4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" name="Rectangle 34">
                  <a:extLst>
                    <a:ext uri="{FF2B5EF4-FFF2-40B4-BE49-F238E27FC236}">
                      <a16:creationId xmlns:a16="http://schemas.microsoft.com/office/drawing/2014/main" id="{19FE8DD3-7E48-4686-902E-7B04F21B35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04696" y="5621901"/>
                  <a:ext cx="1035540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observed</a:t>
                  </a:r>
                  <a:r>
                    <a:rPr kumimoji="0" lang="fr-FR" altLang="fr-FR" sz="10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CSPG4</a:t>
                  </a:r>
                  <a:endParaRPr kumimoji="0" lang="fr-FR" altLang="fr-FR" sz="1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" name="Rectangle 35">
                  <a:extLst>
                    <a:ext uri="{FF2B5EF4-FFF2-40B4-BE49-F238E27FC236}">
                      <a16:creationId xmlns:a16="http://schemas.microsoft.com/office/drawing/2014/main" id="{8E3BFAF1-C726-45D6-9DDE-6583C85F4F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517647" y="3983742"/>
                  <a:ext cx="1085233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score (Pearson, r)</a:t>
                  </a:r>
                  <a:endParaRPr kumimoji="0" lang="fr-FR" altLang="fr-FR" sz="1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0" name="Rectangle 37">
                  <a:extLst>
                    <a:ext uri="{FF2B5EF4-FFF2-40B4-BE49-F238E27FC236}">
                      <a16:creationId xmlns:a16="http://schemas.microsoft.com/office/drawing/2014/main" id="{151DB514-CE43-42E4-82D1-B12CF931F7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22705" y="3186767"/>
                  <a:ext cx="599523" cy="16281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=7.52E-27</a:t>
                  </a:r>
                  <a:endParaRPr kumimoji="0" lang="fr-FR" altLang="fr-FR" sz="9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cxnSp>
            <p:nvCxnSpPr>
              <p:cNvPr id="7" name="Connecteur droit 6">
                <a:extLst>
                  <a:ext uri="{FF2B5EF4-FFF2-40B4-BE49-F238E27FC236}">
                    <a16:creationId xmlns:a16="http://schemas.microsoft.com/office/drawing/2014/main" id="{5D0B7081-D2D2-4A14-86E6-4550535094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45904" y="1908598"/>
                <a:ext cx="1463675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7" name="Groupe 126">
              <a:extLst>
                <a:ext uri="{FF2B5EF4-FFF2-40B4-BE49-F238E27FC236}">
                  <a16:creationId xmlns:a16="http://schemas.microsoft.com/office/drawing/2014/main" id="{9555506B-19BA-4AD9-8D7A-32D9998E3ECC}"/>
                </a:ext>
              </a:extLst>
            </p:cNvPr>
            <p:cNvGrpSpPr/>
            <p:nvPr/>
          </p:nvGrpSpPr>
          <p:grpSpPr>
            <a:xfrm>
              <a:off x="6565105" y="1136650"/>
              <a:ext cx="183113" cy="1577250"/>
              <a:chOff x="3308350" y="4279900"/>
              <a:chExt cx="183113" cy="1577250"/>
            </a:xfrm>
          </p:grpSpPr>
          <p:sp>
            <p:nvSpPr>
              <p:cNvPr id="128" name="Rectangle 61">
                <a:extLst>
                  <a:ext uri="{FF2B5EF4-FFF2-40B4-BE49-F238E27FC236}">
                    <a16:creationId xmlns:a16="http://schemas.microsoft.com/office/drawing/2014/main" id="{F796E042-E7CD-4A78-9539-31F100338C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235784" y="4624578"/>
                <a:ext cx="35747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latin typeface="Arial" panose="020B0604020202020204" pitchFamily="34" charset="0"/>
                  </a:rPr>
                  <a:t>high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" name="Rectangle 61">
                <a:extLst>
                  <a:ext uri="{FF2B5EF4-FFF2-40B4-BE49-F238E27FC236}">
                    <a16:creationId xmlns:a16="http://schemas.microsoft.com/office/drawing/2014/main" id="{5B21921B-3713-43F3-BBB3-8CCA0E212D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235784" y="5411978"/>
                <a:ext cx="35747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 err="1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latin typeface="Arial" panose="020B0604020202020204" pitchFamily="34" charset="0"/>
                  </a:rPr>
                  <a:t>low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cxnSp>
            <p:nvCxnSpPr>
              <p:cNvPr id="130" name="Connecteur droit avec flèche 129">
                <a:extLst>
                  <a:ext uri="{FF2B5EF4-FFF2-40B4-BE49-F238E27FC236}">
                    <a16:creationId xmlns:a16="http://schemas.microsoft.com/office/drawing/2014/main" id="{3C6B3926-C9C9-42CB-8A73-6DE99DCA3C5E}"/>
                  </a:ext>
                </a:extLst>
              </p:cNvPr>
              <p:cNvCxnSpPr/>
              <p:nvPr/>
            </p:nvCxnSpPr>
            <p:spPr>
              <a:xfrm flipV="1">
                <a:off x="3308350" y="4279900"/>
                <a:ext cx="0" cy="720000"/>
              </a:xfrm>
              <a:prstGeom prst="straightConnector1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sys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Connecteur droit avec flèche 130">
                <a:extLst>
                  <a:ext uri="{FF2B5EF4-FFF2-40B4-BE49-F238E27FC236}">
                    <a16:creationId xmlns:a16="http://schemas.microsoft.com/office/drawing/2014/main" id="{60E7980B-AFF9-44CC-B837-AB3C2FEC68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08350" y="5137150"/>
                <a:ext cx="0" cy="720000"/>
              </a:xfrm>
              <a:prstGeom prst="straightConnector1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sys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32" name="ZoneTexte 54">
            <a:extLst>
              <a:ext uri="{FF2B5EF4-FFF2-40B4-BE49-F238E27FC236}">
                <a16:creationId xmlns:a16="http://schemas.microsoft.com/office/drawing/2014/main" id="{3C88B066-AECB-4C6D-A995-F5723A31ED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33669" y="5790745"/>
            <a:ext cx="124906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1000" dirty="0" err="1">
                <a:latin typeface="Arial" panose="020B0604020202020204" pitchFamily="34" charset="0"/>
              </a:rPr>
              <a:t>Fisher’s</a:t>
            </a:r>
            <a:r>
              <a:rPr lang="fr-FR" altLang="fr-FR" sz="1000" dirty="0">
                <a:latin typeface="Arial" panose="020B0604020202020204" pitchFamily="34" charset="0"/>
              </a:rPr>
              <a:t> exact test,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1000" dirty="0">
                <a:latin typeface="Arial" panose="020B0604020202020204" pitchFamily="34" charset="0"/>
              </a:rPr>
              <a:t>p=4.76E-23</a:t>
            </a:r>
          </a:p>
        </p:txBody>
      </p:sp>
      <p:grpSp>
        <p:nvGrpSpPr>
          <p:cNvPr id="133" name="Group 28">
            <a:extLst>
              <a:ext uri="{FF2B5EF4-FFF2-40B4-BE49-F238E27FC236}">
                <a16:creationId xmlns:a16="http://schemas.microsoft.com/office/drawing/2014/main" id="{2F5EDAF1-D2ED-41D8-827B-9A59FBB4450E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060356" y="4571754"/>
            <a:ext cx="1726932" cy="1087218"/>
            <a:chOff x="913" y="2506"/>
            <a:chExt cx="1566" cy="542"/>
          </a:xfrm>
        </p:grpSpPr>
        <p:sp>
          <p:nvSpPr>
            <p:cNvPr id="134" name="Rectangle 29">
              <a:extLst>
                <a:ext uri="{FF2B5EF4-FFF2-40B4-BE49-F238E27FC236}">
                  <a16:creationId xmlns:a16="http://schemas.microsoft.com/office/drawing/2014/main" id="{C70602E7-5D52-431D-918A-0F34E63AE7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5" y="2506"/>
              <a:ext cx="1058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b="1" dirty="0">
                  <a:solidFill>
                    <a:srgbClr val="000000"/>
                  </a:solidFill>
                </a:rPr>
                <a:t>CSPG4 classification</a:t>
              </a:r>
              <a:endParaRPr lang="fr-FR" altLang="fr-FR" sz="1800" b="1" dirty="0">
                <a:latin typeface="Arial" panose="020B0604020202020204" pitchFamily="34" charset="0"/>
              </a:endParaRPr>
            </a:p>
          </p:txBody>
        </p:sp>
        <p:sp>
          <p:nvSpPr>
            <p:cNvPr id="135" name="Rectangle 30">
              <a:extLst>
                <a:ext uri="{FF2B5EF4-FFF2-40B4-BE49-F238E27FC236}">
                  <a16:creationId xmlns:a16="http://schemas.microsoft.com/office/drawing/2014/main" id="{F866D458-D652-49DA-9F03-85A70314B2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5" y="2686"/>
              <a:ext cx="4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>
                  <a:solidFill>
                    <a:srgbClr val="000000"/>
                  </a:solidFill>
                </a:rPr>
                <a:t>Observed</a:t>
              </a:r>
              <a:endParaRPr lang="fr-FR" altLang="fr-FR" sz="1800">
                <a:latin typeface="Arial" panose="020B0604020202020204" pitchFamily="34" charset="0"/>
              </a:endParaRPr>
            </a:p>
          </p:txBody>
        </p:sp>
        <p:sp>
          <p:nvSpPr>
            <p:cNvPr id="136" name="Rectangle 31">
              <a:extLst>
                <a:ext uri="{FF2B5EF4-FFF2-40B4-BE49-F238E27FC236}">
                  <a16:creationId xmlns:a16="http://schemas.microsoft.com/office/drawing/2014/main" id="{2D8F59D2-E785-4C24-9743-780C1EE0F0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" y="2698"/>
              <a:ext cx="18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>
                  <a:solidFill>
                    <a:srgbClr val="000000"/>
                  </a:solidFill>
                </a:rPr>
                <a:t>low</a:t>
              </a:r>
              <a:endParaRPr lang="fr-FR" altLang="fr-FR" sz="1800">
                <a:latin typeface="Arial" panose="020B0604020202020204" pitchFamily="34" charset="0"/>
              </a:endParaRPr>
            </a:p>
          </p:txBody>
        </p:sp>
        <p:sp>
          <p:nvSpPr>
            <p:cNvPr id="137" name="Rectangle 32">
              <a:extLst>
                <a:ext uri="{FF2B5EF4-FFF2-40B4-BE49-F238E27FC236}">
                  <a16:creationId xmlns:a16="http://schemas.microsoft.com/office/drawing/2014/main" id="{E3C45700-B1F0-4E7A-8CBE-F8622E325E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8" y="2698"/>
              <a:ext cx="222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>
                  <a:solidFill>
                    <a:srgbClr val="000000"/>
                  </a:solidFill>
                </a:rPr>
                <a:t>high</a:t>
              </a:r>
              <a:endParaRPr lang="fr-FR" altLang="fr-FR" sz="1800">
                <a:latin typeface="Arial" panose="020B0604020202020204" pitchFamily="34" charset="0"/>
              </a:endParaRPr>
            </a:p>
          </p:txBody>
        </p:sp>
        <p:sp>
          <p:nvSpPr>
            <p:cNvPr id="138" name="Rectangle 33">
              <a:extLst>
                <a:ext uri="{FF2B5EF4-FFF2-40B4-BE49-F238E27FC236}">
                  <a16:creationId xmlns:a16="http://schemas.microsoft.com/office/drawing/2014/main" id="{B7D751B5-DA93-4861-9017-A78CDE66C1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4" y="2817"/>
              <a:ext cx="18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 err="1">
                  <a:solidFill>
                    <a:srgbClr val="000000"/>
                  </a:solidFill>
                </a:rPr>
                <a:t>low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39" name="Rectangle 34">
              <a:extLst>
                <a:ext uri="{FF2B5EF4-FFF2-40B4-BE49-F238E27FC236}">
                  <a16:creationId xmlns:a16="http://schemas.microsoft.com/office/drawing/2014/main" id="{CA289D2F-E02D-4B76-BD5F-BB5D85DB6F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2" y="2817"/>
              <a:ext cx="196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325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40" name="Rectangle 35">
              <a:extLst>
                <a:ext uri="{FF2B5EF4-FFF2-40B4-BE49-F238E27FC236}">
                  <a16:creationId xmlns:a16="http://schemas.microsoft.com/office/drawing/2014/main" id="{5A277E1E-BC2D-41CA-A95E-93B096598C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1" y="2817"/>
              <a:ext cx="196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185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41" name="Rectangle 36">
              <a:extLst>
                <a:ext uri="{FF2B5EF4-FFF2-40B4-BE49-F238E27FC236}">
                  <a16:creationId xmlns:a16="http://schemas.microsoft.com/office/drawing/2014/main" id="{954D9FFE-634F-4A2C-8BD6-929AF63FC6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4" y="2935"/>
              <a:ext cx="222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high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42" name="Rectangle 37">
              <a:extLst>
                <a:ext uri="{FF2B5EF4-FFF2-40B4-BE49-F238E27FC236}">
                  <a16:creationId xmlns:a16="http://schemas.microsoft.com/office/drawing/2014/main" id="{58F4867C-0497-4A52-AF3C-DDE15A5BB2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3" y="2935"/>
              <a:ext cx="196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187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43" name="Rectangle 38">
              <a:extLst>
                <a:ext uri="{FF2B5EF4-FFF2-40B4-BE49-F238E27FC236}">
                  <a16:creationId xmlns:a16="http://schemas.microsoft.com/office/drawing/2014/main" id="{D92CDCCB-332E-4C8B-804E-91AEC9EF03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1" y="2935"/>
              <a:ext cx="196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>
                  <a:solidFill>
                    <a:srgbClr val="000000"/>
                  </a:solidFill>
                </a:rPr>
                <a:t>371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44" name="Rectangle 39">
              <a:extLst>
                <a:ext uri="{FF2B5EF4-FFF2-40B4-BE49-F238E27FC236}">
                  <a16:creationId xmlns:a16="http://schemas.microsoft.com/office/drawing/2014/main" id="{01E62B22-53F4-48EB-ACD7-BC093077BD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0" y="2609"/>
              <a:ext cx="49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100" dirty="0" err="1">
                  <a:solidFill>
                    <a:srgbClr val="000000"/>
                  </a:solidFill>
                </a:rPr>
                <a:t>Predicted</a:t>
              </a:r>
              <a:endParaRPr lang="fr-FR" altLang="fr-FR" sz="1800" dirty="0">
                <a:latin typeface="Arial" panose="020B0604020202020204" pitchFamily="34" charset="0"/>
              </a:endParaRPr>
            </a:p>
          </p:txBody>
        </p:sp>
        <p:sp>
          <p:nvSpPr>
            <p:cNvPr id="145" name="Line 40">
              <a:extLst>
                <a:ext uri="{FF2B5EF4-FFF2-40B4-BE49-F238E27FC236}">
                  <a16:creationId xmlns:a16="http://schemas.microsoft.com/office/drawing/2014/main" id="{A7A16C23-16C0-42CA-85C8-9F8A859CFD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5" y="2687"/>
              <a:ext cx="0" cy="36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fr-FR"/>
            </a:p>
          </p:txBody>
        </p:sp>
        <p:sp>
          <p:nvSpPr>
            <p:cNvPr id="146" name="Line 42">
              <a:extLst>
                <a:ext uri="{FF2B5EF4-FFF2-40B4-BE49-F238E27FC236}">
                  <a16:creationId xmlns:a16="http://schemas.microsoft.com/office/drawing/2014/main" id="{F960216A-F9BC-4C4E-A0D9-1889083C16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9" y="2687"/>
              <a:ext cx="0" cy="36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fr-FR"/>
            </a:p>
          </p:txBody>
        </p:sp>
        <p:sp>
          <p:nvSpPr>
            <p:cNvPr id="147" name="Line 44">
              <a:extLst>
                <a:ext uri="{FF2B5EF4-FFF2-40B4-BE49-F238E27FC236}">
                  <a16:creationId xmlns:a16="http://schemas.microsoft.com/office/drawing/2014/main" id="{09EBE571-D977-4236-ACCA-0F834EFBD8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3" y="2805"/>
              <a:ext cx="156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fr-FR"/>
            </a:p>
          </p:txBody>
        </p:sp>
        <p:sp>
          <p:nvSpPr>
            <p:cNvPr id="148" name="Line 46">
              <a:extLst>
                <a:ext uri="{FF2B5EF4-FFF2-40B4-BE49-F238E27FC236}">
                  <a16:creationId xmlns:a16="http://schemas.microsoft.com/office/drawing/2014/main" id="{1F3ABC7F-691F-43C6-ABC7-65280AF0D0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3" y="3048"/>
              <a:ext cx="156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5695779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</TotalTime>
  <Words>98</Words>
  <Application>Microsoft Office PowerPoint</Application>
  <PresentationFormat>Format A4 (210 x 297 mm)</PresentationFormat>
  <Paragraphs>6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Finetti</dc:creator>
  <cp:lastModifiedBy>BERTUCCI Francois</cp:lastModifiedBy>
  <cp:revision>7</cp:revision>
  <dcterms:created xsi:type="dcterms:W3CDTF">2022-08-29T17:36:52Z</dcterms:created>
  <dcterms:modified xsi:type="dcterms:W3CDTF">2022-09-24T05:20:25Z</dcterms:modified>
</cp:coreProperties>
</file>